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7" r:id="rId4"/>
    <p:sldId id="268" r:id="rId5"/>
    <p:sldId id="269" r:id="rId6"/>
    <p:sldId id="270" r:id="rId7"/>
    <p:sldId id="271" r:id="rId8"/>
    <p:sldId id="272" r:id="rId9"/>
    <p:sldId id="273" r:id="rId10"/>
    <p:sldId id="276" r:id="rId11"/>
    <p:sldId id="275" r:id="rId12"/>
    <p:sldId id="302" r:id="rId13"/>
    <p:sldId id="280" r:id="rId14"/>
    <p:sldId id="281" r:id="rId15"/>
    <p:sldId id="282" r:id="rId16"/>
    <p:sldId id="299" r:id="rId17"/>
    <p:sldId id="283" r:id="rId18"/>
    <p:sldId id="298" r:id="rId19"/>
    <p:sldId id="300" r:id="rId20"/>
    <p:sldId id="303" r:id="rId21"/>
    <p:sldId id="285" r:id="rId22"/>
    <p:sldId id="304" r:id="rId23"/>
    <p:sldId id="284" r:id="rId24"/>
    <p:sldId id="305" r:id="rId25"/>
    <p:sldId id="307" r:id="rId26"/>
    <p:sldId id="306" r:id="rId27"/>
    <p:sldId id="308" r:id="rId28"/>
    <p:sldId id="292" r:id="rId29"/>
    <p:sldId id="294" r:id="rId30"/>
    <p:sldId id="295" r:id="rId31"/>
    <p:sldId id="293" r:id="rId32"/>
    <p:sldId id="296" r:id="rId33"/>
    <p:sldId id="297" r:id="rId3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8EDF6"/>
    <a:srgbClr val="B90797"/>
    <a:srgbClr val="F737E9"/>
    <a:srgbClr val="0408BC"/>
    <a:srgbClr val="009999"/>
    <a:srgbClr val="070FB9"/>
    <a:srgbClr val="5AE747"/>
    <a:srgbClr val="759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1" d="100"/>
          <a:sy n="101" d="100"/>
        </p:scale>
        <p:origin x="29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867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39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50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45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22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61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57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68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22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155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032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AA3DD-0F4D-4682-9FD3-E233111CB4D4}" type="datetimeFigureOut">
              <a:rPr lang="en-US" smtClean="0"/>
              <a:t>9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3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9476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29400" y="4484132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691917" y="6858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1a</a:t>
            </a: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01687" y="401319"/>
            <a:ext cx="2208713" cy="58470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D225B51-C32E-43E9-ADA5-174E9259FF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8800" y="417096"/>
            <a:ext cx="3141449" cy="6029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2470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76800" y="347043"/>
            <a:ext cx="2816109" cy="58357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19800" y="29834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2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553200" y="1078468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B90797"/>
                </a:solidFill>
              </a:rPr>
              <a:t>OG-GELP-C2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553200" y="47244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2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615617-EADF-4ED7-BC7D-4C1BF9A29C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350999"/>
            <a:ext cx="3691890" cy="61661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39668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437119" y="516938"/>
            <a:ext cx="1348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3D15BFF-FD5A-47FE-BEE9-356E2DE902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914400"/>
            <a:ext cx="4585788" cy="59272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78F763E-026F-4E57-A043-A906675379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5193676" y="881390"/>
            <a:ext cx="3416924" cy="5647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15575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888098" y="6144474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GELP-C4X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02136" y="994804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4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23383" y="2286000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3898" y="206494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347796" y="107012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E093DDE-2B92-47A9-BF63-D598069951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1200" y="439170"/>
            <a:ext cx="5410200" cy="6243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93974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7FD0C7C-9893-4515-A4CB-4B3545F76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588770"/>
            <a:ext cx="2023365" cy="626923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229189"/>
            <a:ext cx="16930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-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715000" y="3244334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4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79706" y="1570383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909904" y="4876800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00400" y="621268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2">
                    <a:lumMod val="50000"/>
                  </a:schemeClr>
                </a:solidFill>
              </a:rPr>
              <a:t>OG-GELP-C4Y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00400" y="5955268"/>
            <a:ext cx="1475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G-GELP-C4X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75CEC8A-3A71-4A20-98AD-E13021C434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419600" y="847576"/>
            <a:ext cx="1543304" cy="4925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09456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200" y="229189"/>
            <a:ext cx="15744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X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77000" y="1371600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705600" y="4507468"/>
            <a:ext cx="142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f</a:t>
            </a:r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49914" y="168480"/>
            <a:ext cx="2213790" cy="62128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F1B6109-E79E-4709-B567-F93C777C62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0" y="182335"/>
            <a:ext cx="3127598" cy="6407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09907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FD07334F-3625-4813-9BA5-E48BE45D96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755" y="224586"/>
            <a:ext cx="6782845" cy="66334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" y="229189"/>
            <a:ext cx="18886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6120" y="2484267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h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908130" y="990600"/>
            <a:ext cx="1404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i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81800" y="5486400"/>
            <a:ext cx="145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4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38400" y="6368534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5A4C7A-4D3D-4B44-8564-D4CB3A5B390A}"/>
              </a:ext>
            </a:extLst>
          </p:cNvPr>
          <p:cNvSpPr txBox="1"/>
          <p:nvPr/>
        </p:nvSpPr>
        <p:spPr>
          <a:xfrm>
            <a:off x="7349563" y="3733800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Y</a:t>
            </a:r>
          </a:p>
        </p:txBody>
      </p:sp>
    </p:spTree>
    <p:extLst>
      <p:ext uri="{BB962C8B-B14F-4D97-AF65-F5344CB8AC3E}">
        <p14:creationId xmlns:p14="http://schemas.microsoft.com/office/powerpoint/2010/main" val="22846848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3956BA-CD0C-428F-B743-0BBF0CBAB8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12"/>
          <a:stretch/>
        </p:blipFill>
        <p:spPr>
          <a:xfrm>
            <a:off x="1662610" y="76199"/>
            <a:ext cx="2756990" cy="6662927"/>
          </a:xfrm>
          <a:prstGeom prst="rect">
            <a:avLst/>
          </a:prstGeom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343400" y="48966"/>
            <a:ext cx="1980225" cy="6748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744154" y="229189"/>
            <a:ext cx="19062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32260" y="3200400"/>
            <a:ext cx="1404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i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81000" y="1066800"/>
            <a:ext cx="1472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tx2">
                    <a:lumMod val="75000"/>
                  </a:schemeClr>
                </a:solidFill>
              </a:rPr>
              <a:t>Monocot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33400" y="5334000"/>
            <a:ext cx="9766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009999"/>
                </a:solidFill>
              </a:rPr>
              <a:t>Dicots</a:t>
            </a:r>
          </a:p>
        </p:txBody>
      </p:sp>
    </p:spTree>
    <p:extLst>
      <p:ext uri="{BB962C8B-B14F-4D97-AF65-F5344CB8AC3E}">
        <p14:creationId xmlns:p14="http://schemas.microsoft.com/office/powerpoint/2010/main" val="19952731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CC28333-A613-44FD-A170-2DEBA75586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3600" y="533400"/>
            <a:ext cx="2591196" cy="5911596"/>
          </a:xfrm>
          <a:prstGeom prst="rect">
            <a:avLst/>
          </a:prstGeom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2524" y="533400"/>
            <a:ext cx="1979676" cy="5911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744154" y="229189"/>
            <a:ext cx="18582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32260" y="21336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59333" y="2967335"/>
            <a:ext cx="1472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B90797"/>
                </a:solidFill>
              </a:rPr>
              <a:t>Monocot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1518" y="533400"/>
            <a:ext cx="9766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F737E9"/>
                </a:solidFill>
              </a:rPr>
              <a:t>Dico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156FBD-4EF1-410D-9798-8D22DD701FFA}"/>
              </a:ext>
            </a:extLst>
          </p:cNvPr>
          <p:cNvSpPr txBox="1"/>
          <p:nvPr/>
        </p:nvSpPr>
        <p:spPr>
          <a:xfrm>
            <a:off x="6274461" y="5791200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Y</a:t>
            </a:r>
          </a:p>
        </p:txBody>
      </p:sp>
    </p:spTree>
    <p:extLst>
      <p:ext uri="{BB962C8B-B14F-4D97-AF65-F5344CB8AC3E}">
        <p14:creationId xmlns:p14="http://schemas.microsoft.com/office/powerpoint/2010/main" val="277981251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EB8DBAE-89F7-47E8-AD69-88C694FBCA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0" y="848264"/>
            <a:ext cx="3891788" cy="578113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ED4900-81C8-4951-A913-8D8EF5B8F2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5433110" y="848264"/>
            <a:ext cx="2894497" cy="546068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744154" y="229189"/>
            <a:ext cx="19062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81800" y="2983468"/>
            <a:ext cx="145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4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8486" y="5257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d</a:t>
            </a:r>
          </a:p>
        </p:txBody>
      </p:sp>
    </p:spTree>
    <p:extLst>
      <p:ext uri="{BB962C8B-B14F-4D97-AF65-F5344CB8AC3E}">
        <p14:creationId xmlns:p14="http://schemas.microsoft.com/office/powerpoint/2010/main" val="3093945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143444" y="42026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E674E7-7DDB-4B06-BDD7-D0E8F845AA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199424" y="0"/>
            <a:ext cx="474515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25126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3B63ADF-7CF5-40AB-96CA-82136768B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0" y="536816"/>
            <a:ext cx="2553190" cy="619462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026046" y="882134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5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010143" y="30596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5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BC8369-C441-4250-BE59-9CB657472E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120895" y="530024"/>
            <a:ext cx="1854289" cy="6042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541778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275902" y="377061"/>
            <a:ext cx="2981762" cy="59184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0" y="3733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6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86600" y="12192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6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70538" y="5193268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6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B1AC2DC-D006-426A-95E6-14EE49288D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5508" y="381001"/>
            <a:ext cx="4100892" cy="6188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150902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66C13A6E-1799-4F24-B9E9-B86FE769C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7074" y="299078"/>
            <a:ext cx="2710370" cy="633032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DD9DAF8-BDA9-4C1E-BB5B-CF0836D92C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675" y="972666"/>
            <a:ext cx="2705445" cy="5164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8A29A4F-24BD-4F4B-B65A-0BEA24EFD0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1320" y="965056"/>
            <a:ext cx="1960680" cy="5164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D9D30B5-73BC-4331-800E-43D35E2604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66"/>
          <a:stretch/>
        </p:blipFill>
        <p:spPr>
          <a:xfrm>
            <a:off x="7233312" y="318868"/>
            <a:ext cx="1852883" cy="609374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54336" y="990600"/>
            <a:ext cx="1176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70FB9"/>
                </a:solidFill>
              </a:rPr>
              <a:t>OG-GELP-C7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0" y="6096000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</a:rPr>
              <a:t>OG-GELP-C7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736872" y="454223"/>
            <a:ext cx="1164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5AE747"/>
                </a:solidFill>
              </a:rPr>
              <a:t>OG-GELP-C7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96200" y="1600200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737E9"/>
                </a:solidFill>
              </a:rPr>
              <a:t>OG-GELP-C7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87433" y="2740223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38EDF6"/>
                </a:solidFill>
              </a:rPr>
              <a:t>OG-GELP-C7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467600" y="4111823"/>
            <a:ext cx="11448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B90797"/>
                </a:solidFill>
              </a:rPr>
              <a:t>OG-GELP-C7f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727254" y="5334000"/>
            <a:ext cx="11737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759040"/>
                </a:solidFill>
              </a:rPr>
              <a:t>OG-GELP-C7g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315200" y="6245423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OG-GELP-C7h</a:t>
            </a:r>
          </a:p>
        </p:txBody>
      </p:sp>
    </p:spTree>
    <p:extLst>
      <p:ext uri="{BB962C8B-B14F-4D97-AF65-F5344CB8AC3E}">
        <p14:creationId xmlns:p14="http://schemas.microsoft.com/office/powerpoint/2010/main" val="27305484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EC73E0-9FAA-48E0-9291-4561928A2E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482035" y="478014"/>
            <a:ext cx="6158778" cy="59647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6754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-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395162" y="20574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743160" y="56388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8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13209" y="4648200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</a:t>
            </a:r>
          </a:p>
        </p:txBody>
      </p:sp>
    </p:spTree>
    <p:extLst>
      <p:ext uri="{BB962C8B-B14F-4D97-AF65-F5344CB8AC3E}">
        <p14:creationId xmlns:p14="http://schemas.microsoft.com/office/powerpoint/2010/main" val="62867614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1C27F08D-8D0B-40F7-B2D8-86F559AC07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7400" y="228021"/>
            <a:ext cx="2708028" cy="632517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6930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-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509886" y="5257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800451" y="9906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8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00400" y="444632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AEC0FEF-D554-45E3-BE20-91C31A6A9F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572000" y="917460"/>
            <a:ext cx="1541505" cy="54344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872035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89C2F8-2356-45F9-B517-7BE192EEF2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194" y="152400"/>
            <a:ext cx="5497611" cy="6553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5744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858000" y="62929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8X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58000" y="542186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2</a:t>
            </a:r>
          </a:p>
        </p:txBody>
      </p:sp>
    </p:spTree>
    <p:extLst>
      <p:ext uri="{BB962C8B-B14F-4D97-AF65-F5344CB8AC3E}">
        <p14:creationId xmlns:p14="http://schemas.microsoft.com/office/powerpoint/2010/main" val="239321359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68B7BA0A-1A1B-4C6D-9517-21334C4365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949100" y="685800"/>
            <a:ext cx="3432897" cy="560812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9D6BC15-B072-4AA5-8273-BB752B81D2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" y="716480"/>
            <a:ext cx="4816578" cy="59123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65738" y="5802868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8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57722" y="24384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8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784974" y="1040093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c</a:t>
            </a:r>
          </a:p>
        </p:txBody>
      </p:sp>
    </p:spTree>
    <p:extLst>
      <p:ext uri="{BB962C8B-B14F-4D97-AF65-F5344CB8AC3E}">
        <p14:creationId xmlns:p14="http://schemas.microsoft.com/office/powerpoint/2010/main" val="37150380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127502" y="2831068"/>
            <a:ext cx="142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8f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445E9EF-9394-4EC7-8A23-6452D06E6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2888" y="152400"/>
            <a:ext cx="3016176" cy="6553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B0439FE-D030-4783-894F-0FE8A3B481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724400" y="152400"/>
            <a:ext cx="2057400" cy="6366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10429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334000" y="345693"/>
            <a:ext cx="3195271" cy="58265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9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239000" y="11430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9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239000" y="49646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9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EF10919-07D5-4715-AC8B-21E3E29436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9200" y="348486"/>
            <a:ext cx="4375405" cy="6128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17779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D592D96E-9593-47AE-8553-6E07B06F3F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381001"/>
            <a:ext cx="5829184" cy="6019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6200" y="229189"/>
            <a:ext cx="1556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14233" y="773668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0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521326" y="5208300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f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819400" y="164068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10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4118" y="1567934"/>
            <a:ext cx="1561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10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75604" y="5884067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10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14600" y="6253399"/>
            <a:ext cx="1579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10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5639" y="3810000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10X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67599" y="1752600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GELP-C10Y</a:t>
            </a:r>
          </a:p>
        </p:txBody>
      </p:sp>
    </p:spTree>
    <p:extLst>
      <p:ext uri="{BB962C8B-B14F-4D97-AF65-F5344CB8AC3E}">
        <p14:creationId xmlns:p14="http://schemas.microsoft.com/office/powerpoint/2010/main" val="32893719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F399DE8-CBEC-4DFD-8807-C56B890305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586346" y="280709"/>
            <a:ext cx="5818909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400800" y="2702942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2</a:t>
            </a:r>
          </a:p>
        </p:txBody>
      </p:sp>
    </p:spTree>
    <p:extLst>
      <p:ext uri="{BB962C8B-B14F-4D97-AF65-F5344CB8AC3E}">
        <p14:creationId xmlns:p14="http://schemas.microsoft.com/office/powerpoint/2010/main" val="345644927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C08842C3-1851-4F97-805C-C568D02BD4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0" y="52924"/>
            <a:ext cx="2375204" cy="670840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90148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-b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840"/>
          <a:stretch/>
        </p:blipFill>
        <p:spPr bwMode="auto">
          <a:xfrm flipH="1">
            <a:off x="4495800" y="4649638"/>
            <a:ext cx="1766970" cy="19513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946"/>
          <a:stretch/>
        </p:blipFill>
        <p:spPr bwMode="auto">
          <a:xfrm flipH="1">
            <a:off x="4495800" y="304800"/>
            <a:ext cx="1766970" cy="412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324600" y="304800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0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324600" y="785209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f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321475" y="2000056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10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324600" y="3810000"/>
            <a:ext cx="1561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10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316667" y="510540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10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326285" y="6096000"/>
            <a:ext cx="1579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10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895600" y="432614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10X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048000" y="76200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GELP-C10Y</a:t>
            </a:r>
          </a:p>
        </p:txBody>
      </p:sp>
    </p:spTree>
    <p:extLst>
      <p:ext uri="{BB962C8B-B14F-4D97-AF65-F5344CB8AC3E}">
        <p14:creationId xmlns:p14="http://schemas.microsoft.com/office/powerpoint/2010/main" val="68785867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A59CC5C-3C4C-41FE-BE15-08B0D7691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1" y="685800"/>
            <a:ext cx="4724400" cy="5955943"/>
          </a:xfrm>
          <a:prstGeom prst="rect">
            <a:avLst/>
          </a:prstGeom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802220" y="657236"/>
            <a:ext cx="3036980" cy="5692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X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052160" y="6096000"/>
            <a:ext cx="1574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g</a:t>
            </a:r>
          </a:p>
        </p:txBody>
      </p:sp>
    </p:spTree>
    <p:extLst>
      <p:ext uri="{BB962C8B-B14F-4D97-AF65-F5344CB8AC3E}">
        <p14:creationId xmlns:p14="http://schemas.microsoft.com/office/powerpoint/2010/main" val="380879286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6200" y="229189"/>
            <a:ext cx="17700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52160" y="609600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h</a:t>
            </a: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562610" y="369031"/>
            <a:ext cx="2754544" cy="57848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89D78D-1347-47C9-8BE0-838B60A864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2600" y="387824"/>
            <a:ext cx="3996337" cy="6019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832342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43344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067244" y="31358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A60A3B9-54C9-4F98-A208-6DB9D12555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322087" y="964562"/>
            <a:ext cx="5896346" cy="5593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05761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524444" y="30596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5DEEC7-AB5A-43EB-AA79-3DDA8F4EA5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837269" y="802647"/>
            <a:ext cx="5975776" cy="55896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1232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781800" y="38978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B7BAA4-60A5-48E8-ADAF-7BC3D7C21D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66712" y="568726"/>
            <a:ext cx="5810731" cy="6267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74700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553200" y="31242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3761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6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4E87E97-3ACA-49BE-8B56-C8EBF53470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700229" y="854252"/>
            <a:ext cx="6065523" cy="5484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40285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781800" y="34290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7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CFC253E-4788-4D6A-B538-2409DEAC3E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854529" y="797047"/>
            <a:ext cx="5715000" cy="5747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75379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4BD0C31-FBCD-4DEB-BED0-DC09B11CF7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119985" y="738985"/>
            <a:ext cx="5989630" cy="5943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" y="43434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8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02586" y="229189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8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41357" y="521576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70C0"/>
                </a:solidFill>
              </a:rPr>
              <a:t>Cluster 9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64728" y="4876800"/>
            <a:ext cx="1136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luster 10</a:t>
            </a:r>
          </a:p>
        </p:txBody>
      </p:sp>
    </p:spTree>
    <p:extLst>
      <p:ext uri="{BB962C8B-B14F-4D97-AF65-F5344CB8AC3E}">
        <p14:creationId xmlns:p14="http://schemas.microsoft.com/office/powerpoint/2010/main" val="493918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6</TotalTime>
  <Words>128</Words>
  <Application>Microsoft Office PowerPoint</Application>
  <PresentationFormat>On-screen Show (4:3)</PresentationFormat>
  <Paragraphs>118</Paragraphs>
  <Slides>3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3</vt:i4>
      </vt:variant>
    </vt:vector>
  </HeadingPairs>
  <TitlesOfParts>
    <vt:vector size="3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nci, Alberto (Bioversity-France)</dc:creator>
  <cp:lastModifiedBy>Cenci, Alberto (Alliance Bioversity-CIAT)</cp:lastModifiedBy>
  <cp:revision>200</cp:revision>
  <dcterms:created xsi:type="dcterms:W3CDTF">2020-02-11T10:26:53Z</dcterms:created>
  <dcterms:modified xsi:type="dcterms:W3CDTF">2021-09-28T10:19:42Z</dcterms:modified>
</cp:coreProperties>
</file>